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7"/>
  </p:notesMasterIdLst>
  <p:sldIdLst>
    <p:sldId id="290" r:id="rId2"/>
    <p:sldId id="1243" r:id="rId3"/>
    <p:sldId id="1245" r:id="rId4"/>
    <p:sldId id="1614" r:id="rId5"/>
    <p:sldId id="1615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279"/>
    <p:restoredTop sz="91478"/>
  </p:normalViewPr>
  <p:slideViewPr>
    <p:cSldViewPr snapToGrid="0" snapToObjects="1">
      <p:cViewPr varScale="1">
        <p:scale>
          <a:sx n="78" d="100"/>
          <a:sy n="78" d="100"/>
        </p:scale>
        <p:origin x="3784" y="184"/>
      </p:cViewPr>
      <p:guideLst/>
    </p:cSldViewPr>
  </p:slideViewPr>
  <p:notesTextViewPr>
    <p:cViewPr>
      <p:scale>
        <a:sx n="190" d="100"/>
        <a:sy n="19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20E20B-D908-4C45-8717-7DD831061565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CE7AD0-FCB5-EE4D-9585-068D5ECF47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9661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B1C3C5-6C21-2947-ACCF-7FCEE47AE6D1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57388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B1C3C5-6C21-2947-ACCF-7FCEE47AE6D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4873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783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454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046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231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9727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8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607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099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244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640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786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4C495-6560-564D-98BE-0C87133EBFEB}" type="datetimeFigureOut">
              <a:rPr lang="en-US" smtClean="0"/>
              <a:t>12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697F2-AB44-F54C-800D-C57248886C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465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A76EAD-AC53-454E-A8F0-ADBA8FBEAF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s/Table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8C62FB-ABAE-F54D-9A87-57B2EA42C63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5417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AEBF2EE-7B06-9A4E-86CC-974F32820917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4394" y="3649240"/>
            <a:ext cx="6938166" cy="28190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371F2C0-CFF8-4B46-BFE9-590C81854887}"/>
              </a:ext>
            </a:extLst>
          </p:cNvPr>
          <p:cNvSpPr txBox="1"/>
          <p:nvPr/>
        </p:nvSpPr>
        <p:spPr>
          <a:xfrm>
            <a:off x="6898003" y="2942739"/>
            <a:ext cx="896399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>
                <a:solidFill>
                  <a:srgbClr val="FF0000"/>
                </a:solidFill>
              </a:rPr>
              <a:t>Suppl Fig S1</a:t>
            </a:r>
          </a:p>
        </p:txBody>
      </p:sp>
    </p:spTree>
    <p:extLst>
      <p:ext uri="{BB962C8B-B14F-4D97-AF65-F5344CB8AC3E}">
        <p14:creationId xmlns:p14="http://schemas.microsoft.com/office/powerpoint/2010/main" val="4210341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F72E80E-799E-7E4A-9974-C0DF8DCA7FD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9929" r="9389" b="57816"/>
          <a:stretch/>
        </p:blipFill>
        <p:spPr>
          <a:xfrm>
            <a:off x="1235812" y="3632873"/>
            <a:ext cx="3089529" cy="166656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8BDA15E-1298-2042-899E-D56A14BACDA8}"/>
              </a:ext>
            </a:extLst>
          </p:cNvPr>
          <p:cNvSpPr txBox="1"/>
          <p:nvPr/>
        </p:nvSpPr>
        <p:spPr>
          <a:xfrm>
            <a:off x="6898003" y="2942739"/>
            <a:ext cx="896399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>
                <a:solidFill>
                  <a:srgbClr val="FF0000"/>
                </a:solidFill>
              </a:rPr>
              <a:t>Suppl Fig 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C023470-D59E-B64C-A7A1-1355A8546C0D}"/>
              </a:ext>
            </a:extLst>
          </p:cNvPr>
          <p:cNvSpPr txBox="1"/>
          <p:nvPr/>
        </p:nvSpPr>
        <p:spPr>
          <a:xfrm>
            <a:off x="4710074" y="3818672"/>
            <a:ext cx="1997022" cy="1328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18599" indent="-218599">
              <a:buAutoNum type="arabicPeriod"/>
            </a:pPr>
            <a:r>
              <a:rPr lang="en-US" sz="1148" i="1" dirty="0"/>
              <a:t>Sphingobium </a:t>
            </a:r>
            <a:r>
              <a:rPr lang="en-US" sz="1148" i="1" dirty="0" err="1"/>
              <a:t>xenophagum</a:t>
            </a:r>
            <a:endParaRPr lang="en-US" sz="1148" i="1" dirty="0"/>
          </a:p>
          <a:p>
            <a:pPr marL="218599" indent="-218599">
              <a:buAutoNum type="arabicPeriod"/>
            </a:pPr>
            <a:r>
              <a:rPr lang="en-US" sz="1148" i="1" dirty="0"/>
              <a:t>Caulobacter </a:t>
            </a:r>
            <a:r>
              <a:rPr lang="en-US" sz="1148" dirty="0"/>
              <a:t>sp.</a:t>
            </a:r>
          </a:p>
          <a:p>
            <a:pPr marL="218599" indent="-218599">
              <a:buAutoNum type="arabicPeriod"/>
            </a:pPr>
            <a:r>
              <a:rPr lang="en-US" sz="1148" i="1" dirty="0"/>
              <a:t>Commomonadaceae</a:t>
            </a:r>
            <a:r>
              <a:rPr lang="en-US" sz="1148" dirty="0"/>
              <a:t>-1</a:t>
            </a:r>
          </a:p>
          <a:p>
            <a:pPr marL="218599" indent="-218599">
              <a:buAutoNum type="arabicPeriod"/>
            </a:pPr>
            <a:r>
              <a:rPr lang="en-US" sz="1148" i="1" dirty="0"/>
              <a:t>Pseudomonas </a:t>
            </a:r>
            <a:r>
              <a:rPr lang="en-US" sz="1148" i="1" dirty="0" err="1"/>
              <a:t>veronii</a:t>
            </a:r>
            <a:endParaRPr lang="en-US" sz="1148" i="1" dirty="0"/>
          </a:p>
          <a:p>
            <a:pPr marL="218599" indent="-218599">
              <a:buAutoNum type="arabicPeriod"/>
            </a:pPr>
            <a:r>
              <a:rPr lang="en-US" sz="1148" i="1" dirty="0"/>
              <a:t>Blastomonas </a:t>
            </a:r>
            <a:r>
              <a:rPr lang="en-US" sz="1148" dirty="0"/>
              <a:t>sp.</a:t>
            </a:r>
          </a:p>
          <a:p>
            <a:pPr marL="218599" indent="-218599">
              <a:buAutoNum type="arabicPeriod"/>
            </a:pPr>
            <a:r>
              <a:rPr lang="en-US" sz="1148" i="1" dirty="0"/>
              <a:t>Azospira </a:t>
            </a:r>
            <a:r>
              <a:rPr lang="en-US" sz="1148" dirty="0"/>
              <a:t>sp.</a:t>
            </a:r>
          </a:p>
          <a:p>
            <a:pPr marL="218599" indent="-218599">
              <a:buFontTx/>
              <a:buAutoNum type="arabicPeriod"/>
            </a:pPr>
            <a:r>
              <a:rPr lang="en-US" sz="1148" i="1" dirty="0"/>
              <a:t>Commomonadaceae</a:t>
            </a:r>
            <a:r>
              <a:rPr lang="en-US" sz="1148" dirty="0"/>
              <a:t>-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2A18358-446B-B645-8FCD-F9D48D3AFF2D}"/>
              </a:ext>
            </a:extLst>
          </p:cNvPr>
          <p:cNvSpPr txBox="1"/>
          <p:nvPr/>
        </p:nvSpPr>
        <p:spPr>
          <a:xfrm>
            <a:off x="1904592" y="5287783"/>
            <a:ext cx="2395207" cy="26898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48"/>
              <a:t>1        2        3        4         5        6        7 </a:t>
            </a:r>
          </a:p>
        </p:txBody>
      </p:sp>
    </p:spTree>
    <p:extLst>
      <p:ext uri="{BB962C8B-B14F-4D97-AF65-F5344CB8AC3E}">
        <p14:creationId xmlns:p14="http://schemas.microsoft.com/office/powerpoint/2010/main" val="1316234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B041446-D120-E546-8A6E-F1739DEEAD2E}"/>
              </a:ext>
            </a:extLst>
          </p:cNvPr>
          <p:cNvSpPr txBox="1"/>
          <p:nvPr/>
        </p:nvSpPr>
        <p:spPr>
          <a:xfrm>
            <a:off x="6587760" y="2975396"/>
            <a:ext cx="105349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>
                <a:solidFill>
                  <a:srgbClr val="FF0000"/>
                </a:solidFill>
              </a:rPr>
              <a:t>Suppl Table S1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3A146EA-95A7-C74E-82BB-2724621C90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6652374"/>
              </p:ext>
            </p:extLst>
          </p:nvPr>
        </p:nvGraphicFramePr>
        <p:xfrm>
          <a:off x="261258" y="4384902"/>
          <a:ext cx="6939643" cy="1257300"/>
        </p:xfrm>
        <a:graphic>
          <a:graphicData uri="http://schemas.openxmlformats.org/drawingml/2006/table">
            <a:tbl>
              <a:tblPr/>
              <a:tblGrid>
                <a:gridCol w="1763449">
                  <a:extLst>
                    <a:ext uri="{9D8B030D-6E8A-4147-A177-3AD203B41FA5}">
                      <a16:colId xmlns:a16="http://schemas.microsoft.com/office/drawing/2014/main" val="2255409694"/>
                    </a:ext>
                  </a:extLst>
                </a:gridCol>
                <a:gridCol w="1605999">
                  <a:extLst>
                    <a:ext uri="{9D8B030D-6E8A-4147-A177-3AD203B41FA5}">
                      <a16:colId xmlns:a16="http://schemas.microsoft.com/office/drawing/2014/main" val="2142512675"/>
                    </a:ext>
                  </a:extLst>
                </a:gridCol>
                <a:gridCol w="488097">
                  <a:extLst>
                    <a:ext uri="{9D8B030D-6E8A-4147-A177-3AD203B41FA5}">
                      <a16:colId xmlns:a16="http://schemas.microsoft.com/office/drawing/2014/main" val="1345944468"/>
                    </a:ext>
                  </a:extLst>
                </a:gridCol>
                <a:gridCol w="1027366">
                  <a:extLst>
                    <a:ext uri="{9D8B030D-6E8A-4147-A177-3AD203B41FA5}">
                      <a16:colId xmlns:a16="http://schemas.microsoft.com/office/drawing/2014/main" val="208145717"/>
                    </a:ext>
                  </a:extLst>
                </a:gridCol>
                <a:gridCol w="1027366">
                  <a:extLst>
                    <a:ext uri="{9D8B030D-6E8A-4147-A177-3AD203B41FA5}">
                      <a16:colId xmlns:a16="http://schemas.microsoft.com/office/drawing/2014/main" val="1686243407"/>
                    </a:ext>
                  </a:extLst>
                </a:gridCol>
                <a:gridCol w="1027366">
                  <a:extLst>
                    <a:ext uri="{9D8B030D-6E8A-4147-A177-3AD203B41FA5}">
                      <a16:colId xmlns:a16="http://schemas.microsoft.com/office/drawing/2014/main" val="2077773045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ffect Size (R2.adj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f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I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(&gt;F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4993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MA treatmen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82957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0.43815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752427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21011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lection Timestam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43504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3.45078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03386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66272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All variables&gt;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920996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3767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44345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B041446-D120-E546-8A6E-F1739DEEAD2E}"/>
              </a:ext>
            </a:extLst>
          </p:cNvPr>
          <p:cNvSpPr txBox="1"/>
          <p:nvPr/>
        </p:nvSpPr>
        <p:spPr>
          <a:xfrm>
            <a:off x="6587760" y="2975396"/>
            <a:ext cx="105349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>
                <a:solidFill>
                  <a:srgbClr val="FF0000"/>
                </a:solidFill>
              </a:rPr>
              <a:t>Suppl Table S2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0352C4D-1A03-FF42-A121-38B3985BF9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5093109"/>
              </p:ext>
            </p:extLst>
          </p:nvPr>
        </p:nvGraphicFramePr>
        <p:xfrm>
          <a:off x="655864" y="3984171"/>
          <a:ext cx="6365422" cy="2145984"/>
        </p:xfrm>
        <a:graphic>
          <a:graphicData uri="http://schemas.openxmlformats.org/drawingml/2006/table">
            <a:tbl>
              <a:tblPr/>
              <a:tblGrid>
                <a:gridCol w="1659032">
                  <a:extLst>
                    <a:ext uri="{9D8B030D-6E8A-4147-A177-3AD203B41FA5}">
                      <a16:colId xmlns:a16="http://schemas.microsoft.com/office/drawing/2014/main" val="2760715780"/>
                    </a:ext>
                  </a:extLst>
                </a:gridCol>
                <a:gridCol w="1036411">
                  <a:extLst>
                    <a:ext uri="{9D8B030D-6E8A-4147-A177-3AD203B41FA5}">
                      <a16:colId xmlns:a16="http://schemas.microsoft.com/office/drawing/2014/main" val="4139722105"/>
                    </a:ext>
                  </a:extLst>
                </a:gridCol>
                <a:gridCol w="1531414">
                  <a:extLst>
                    <a:ext uri="{9D8B030D-6E8A-4147-A177-3AD203B41FA5}">
                      <a16:colId xmlns:a16="http://schemas.microsoft.com/office/drawing/2014/main" val="1095528773"/>
                    </a:ext>
                  </a:extLst>
                </a:gridCol>
                <a:gridCol w="1129224">
                  <a:extLst>
                    <a:ext uri="{9D8B030D-6E8A-4147-A177-3AD203B41FA5}">
                      <a16:colId xmlns:a16="http://schemas.microsoft.com/office/drawing/2014/main" val="3011954577"/>
                    </a:ext>
                  </a:extLst>
                </a:gridCol>
                <a:gridCol w="1009341">
                  <a:extLst>
                    <a:ext uri="{9D8B030D-6E8A-4147-A177-3AD203B41FA5}">
                      <a16:colId xmlns:a16="http://schemas.microsoft.com/office/drawing/2014/main" val="161684420"/>
                    </a:ext>
                  </a:extLst>
                </a:gridCol>
              </a:tblGrid>
              <a:tr h="3838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Siz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mber of Group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st Statisti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7833826"/>
                  </a:ext>
                </a:extLst>
              </a:tr>
              <a:tr h="3838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ighted UniFra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491625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8098086"/>
                  </a:ext>
                </a:extLst>
              </a:tr>
              <a:tr h="3838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weighted UniFra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165746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432911"/>
                  </a:ext>
                </a:extLst>
              </a:tr>
              <a:tr h="3838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C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3780825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2125394"/>
                  </a:ext>
                </a:extLst>
              </a:tr>
              <a:tr h="3838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F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375775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45385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5047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51</TotalTime>
  <Words>105</Words>
  <Application>Microsoft Macintosh PowerPoint</Application>
  <PresentationFormat>Custom</PresentationFormat>
  <Paragraphs>60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l Figures/Table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kat</dc:creator>
  <cp:lastModifiedBy>Venkat</cp:lastModifiedBy>
  <cp:revision>56</cp:revision>
  <dcterms:created xsi:type="dcterms:W3CDTF">2020-09-07T15:21:25Z</dcterms:created>
  <dcterms:modified xsi:type="dcterms:W3CDTF">2020-12-15T18:36:46Z</dcterms:modified>
</cp:coreProperties>
</file>